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ittlere Formatvorlage 2 - Akz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616DA210-FB5B-4158-B5E0-FEB733F419BA}" styleName="Helle Formatvorlage 3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254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69" d="100"/>
          <a:sy n="69" d="100"/>
        </p:scale>
        <p:origin x="-1452" y="-96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de-DE" smtClean="0"/>
              <a:t>Titelmasterformat durch Klicken bearbeiten</a:t>
            </a:r>
            <a:endParaRPr lang="en-GB"/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de-DE" smtClean="0"/>
              <a:t>Formatvorlage des Untertitelmasters durch Klicken bearbeiten</a:t>
            </a:r>
            <a:endParaRPr lang="en-GB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63DB45-87E8-4545-894B-E80D55B29A8F}" type="datetimeFigureOut">
              <a:rPr lang="en-GB" smtClean="0"/>
              <a:t>28/10/2016</a:t>
            </a:fld>
            <a:endParaRPr lang="en-GB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B1CC81-F83D-415C-9B9C-38081B03531B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74624556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GB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GB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63DB45-87E8-4545-894B-E80D55B29A8F}" type="datetimeFigureOut">
              <a:rPr lang="en-GB" smtClean="0"/>
              <a:t>28/10/2016</a:t>
            </a:fld>
            <a:endParaRPr lang="en-GB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B1CC81-F83D-415C-9B9C-38081B03531B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213467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de-DE" smtClean="0"/>
              <a:t>Titelmasterformat durch Klicken bearbeiten</a:t>
            </a:r>
            <a:endParaRPr lang="en-GB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GB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63DB45-87E8-4545-894B-E80D55B29A8F}" type="datetimeFigureOut">
              <a:rPr lang="en-GB" smtClean="0"/>
              <a:t>28/10/2016</a:t>
            </a:fld>
            <a:endParaRPr lang="en-GB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B1CC81-F83D-415C-9B9C-38081B03531B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4662352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GB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GB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63DB45-87E8-4545-894B-E80D55B29A8F}" type="datetimeFigureOut">
              <a:rPr lang="en-GB" smtClean="0"/>
              <a:t>28/10/2016</a:t>
            </a:fld>
            <a:endParaRPr lang="en-GB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B1CC81-F83D-415C-9B9C-38081B03531B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5575227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de-DE" smtClean="0"/>
              <a:t>Titelmasterformat durch Klicken bearbeiten</a:t>
            </a:r>
            <a:endParaRPr lang="en-GB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63DB45-87E8-4545-894B-E80D55B29A8F}" type="datetimeFigureOut">
              <a:rPr lang="en-GB" smtClean="0"/>
              <a:t>28/10/2016</a:t>
            </a:fld>
            <a:endParaRPr lang="en-GB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B1CC81-F83D-415C-9B9C-38081B03531B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54383827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GB"/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GB"/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GB"/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63DB45-87E8-4545-894B-E80D55B29A8F}" type="datetimeFigureOut">
              <a:rPr lang="en-GB" smtClean="0"/>
              <a:t>28/10/2016</a:t>
            </a:fld>
            <a:endParaRPr lang="en-GB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B1CC81-F83D-415C-9B9C-38081B03531B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1853212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de-DE" smtClean="0"/>
              <a:t>Titelmasterformat durch Klicken bearbeiten</a:t>
            </a:r>
            <a:endParaRPr lang="en-GB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GB"/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GB"/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63DB45-87E8-4545-894B-E80D55B29A8F}" type="datetimeFigureOut">
              <a:rPr lang="en-GB" smtClean="0"/>
              <a:t>28/10/2016</a:t>
            </a:fld>
            <a:endParaRPr lang="en-GB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B1CC81-F83D-415C-9B9C-38081B03531B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2084504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GB"/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63DB45-87E8-4545-894B-E80D55B29A8F}" type="datetimeFigureOut">
              <a:rPr lang="en-GB" smtClean="0"/>
              <a:t>28/10/2016</a:t>
            </a:fld>
            <a:endParaRPr lang="en-GB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B1CC81-F83D-415C-9B9C-38081B03531B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2462096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63DB45-87E8-4545-894B-E80D55B29A8F}" type="datetimeFigureOut">
              <a:rPr lang="en-GB" smtClean="0"/>
              <a:t>28/10/2016</a:t>
            </a:fld>
            <a:endParaRPr lang="en-GB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B1CC81-F83D-415C-9B9C-38081B03531B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1491617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en-GB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GB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63DB45-87E8-4545-894B-E80D55B29A8F}" type="datetimeFigureOut">
              <a:rPr lang="en-GB" smtClean="0"/>
              <a:t>28/10/2016</a:t>
            </a:fld>
            <a:endParaRPr lang="en-GB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B1CC81-F83D-415C-9B9C-38081B03531B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8947401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en-GB"/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63DB45-87E8-4545-894B-E80D55B29A8F}" type="datetimeFigureOut">
              <a:rPr lang="en-GB" smtClean="0"/>
              <a:t>28/10/2016</a:t>
            </a:fld>
            <a:endParaRPr lang="en-GB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B1CC81-F83D-415C-9B9C-38081B03531B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3222365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 smtClean="0"/>
              <a:t>Titelmasterformat durch Klicken bearbeiten</a:t>
            </a:r>
            <a:endParaRPr lang="en-GB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GB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B63DB45-87E8-4545-894B-E80D55B29A8F}" type="datetimeFigureOut">
              <a:rPr lang="en-GB" smtClean="0"/>
              <a:t>28/10/2016</a:t>
            </a:fld>
            <a:endParaRPr lang="en-GB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0B1CC81-F83D-415C-9B9C-38081B03531B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9360985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elle 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21727923"/>
              </p:ext>
            </p:extLst>
          </p:nvPr>
        </p:nvGraphicFramePr>
        <p:xfrm>
          <a:off x="107504" y="836712"/>
          <a:ext cx="4176464" cy="4514894"/>
        </p:xfrm>
        <a:graphic>
          <a:graphicData uri="http://schemas.openxmlformats.org/drawingml/2006/table">
            <a:tbl>
              <a:tblPr>
                <a:tableStyleId>{616DA210-FB5B-4158-B5E0-FEB733F419BA}</a:tableStyleId>
              </a:tblPr>
              <a:tblGrid>
                <a:gridCol w="1044116"/>
                <a:gridCol w="1044116"/>
                <a:gridCol w="1044116"/>
                <a:gridCol w="1044116"/>
              </a:tblGrid>
              <a:tr h="237626">
                <a:tc gridSpan="4"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 dirty="0" smtClean="0">
                          <a:effectLst/>
                        </a:rPr>
                        <a:t>CD34+ </a:t>
                      </a:r>
                      <a:r>
                        <a:rPr lang="en-GB" sz="1100" u="none" strike="noStrike" dirty="0">
                          <a:effectLst/>
                        </a:rPr>
                        <a:t>cell count/</a:t>
                      </a:r>
                      <a:r>
                        <a:rPr lang="en-GB" sz="1100" u="none" strike="noStrike" dirty="0" err="1">
                          <a:effectLst/>
                        </a:rPr>
                        <a:t>ul</a:t>
                      </a:r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algn="l" fontAlgn="b"/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 hMerge="1">
                  <a:txBody>
                    <a:bodyPr/>
                    <a:lstStyle/>
                    <a:p>
                      <a:pPr algn="l" fontAlgn="b"/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</a:tr>
              <a:tr h="237626"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 dirty="0">
                          <a:effectLst/>
                        </a:rPr>
                        <a:t>Placebo</a:t>
                      </a:r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tc hMerge="1">
                  <a:txBody>
                    <a:bodyPr/>
                    <a:lstStyle/>
                    <a:p>
                      <a:pPr algn="l" fontAlgn="b"/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 dirty="0">
                          <a:effectLst/>
                        </a:rPr>
                        <a:t>rHDL</a:t>
                      </a:r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tc hMerge="1">
                  <a:txBody>
                    <a:bodyPr/>
                    <a:lstStyle/>
                    <a:p>
                      <a:pPr algn="l" fontAlgn="b"/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</a:tr>
              <a:tr h="237626"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 dirty="0">
                          <a:effectLst/>
                        </a:rPr>
                        <a:t>baseline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 dirty="0">
                          <a:effectLst/>
                        </a:rPr>
                        <a:t>follow-up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 dirty="0">
                          <a:effectLst/>
                        </a:rPr>
                        <a:t>baseline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 dirty="0">
                          <a:effectLst/>
                        </a:rPr>
                        <a:t>follow-up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</a:tr>
              <a:tr h="237626"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>
                          <a:effectLst/>
                        </a:rPr>
                        <a:t>0.6758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>
                          <a:effectLst/>
                        </a:rPr>
                        <a:t>0.9044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>
                          <a:effectLst/>
                        </a:rPr>
                        <a:t>2.5821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>
                          <a:effectLst/>
                        </a:rPr>
                        <a:t>2.7102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</a:tr>
              <a:tr h="237626"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>
                          <a:effectLst/>
                        </a:rPr>
                        <a:t>3.0411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>
                          <a:effectLst/>
                        </a:rPr>
                        <a:t>1.5318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>
                          <a:effectLst/>
                        </a:rPr>
                        <a:t>0.9709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>
                          <a:effectLst/>
                        </a:rPr>
                        <a:t>1.2786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</a:tr>
              <a:tr h="237626"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>
                          <a:effectLst/>
                        </a:rPr>
                        <a:t>0.9827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>
                          <a:effectLst/>
                        </a:rPr>
                        <a:t>1.1259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>
                          <a:effectLst/>
                        </a:rPr>
                        <a:t>1.3287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>
                          <a:effectLst/>
                        </a:rPr>
                        <a:t>1.0936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</a:tr>
              <a:tr h="237626"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>
                          <a:effectLst/>
                        </a:rPr>
                        <a:t>0.5954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>
                          <a:effectLst/>
                        </a:rPr>
                        <a:t>0.3427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 dirty="0">
                          <a:effectLst/>
                        </a:rPr>
                        <a:t>1.6697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 dirty="0">
                          <a:effectLst/>
                        </a:rPr>
                        <a:t>1.757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</a:tr>
              <a:tr h="237626"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>
                          <a:effectLst/>
                        </a:rPr>
                        <a:t>1.8324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 dirty="0">
                          <a:effectLst/>
                        </a:rPr>
                        <a:t>1.6248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 dirty="0">
                          <a:effectLst/>
                        </a:rPr>
                        <a:t>2.7108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>
                          <a:effectLst/>
                        </a:rPr>
                        <a:t>3.4705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</a:tr>
              <a:tr h="237626"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>
                          <a:effectLst/>
                        </a:rPr>
                        <a:t>0.8532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 dirty="0">
                          <a:effectLst/>
                        </a:rPr>
                        <a:t>0.5713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>
                          <a:effectLst/>
                        </a:rPr>
                        <a:t>2.0888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>
                          <a:effectLst/>
                        </a:rPr>
                        <a:t>1.4337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</a:tr>
              <a:tr h="237626"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>
                          <a:effectLst/>
                        </a:rPr>
                        <a:t>0.9493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>
                          <a:effectLst/>
                        </a:rPr>
                        <a:t>0.6385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>
                          <a:effectLst/>
                        </a:rPr>
                        <a:t>1.9674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>
                          <a:effectLst/>
                        </a:rPr>
                        <a:t>1.1602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</a:tr>
              <a:tr h="237626"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>
                          <a:effectLst/>
                        </a:rPr>
                        <a:t>1.3966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>
                          <a:effectLst/>
                        </a:rPr>
                        <a:t>0.9665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>
                          <a:effectLst/>
                        </a:rPr>
                        <a:t>1.4252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>
                          <a:effectLst/>
                        </a:rPr>
                        <a:t>1.5523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</a:tr>
              <a:tr h="237626"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>
                          <a:effectLst/>
                        </a:rPr>
                        <a:t>1.1842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>
                          <a:effectLst/>
                        </a:rPr>
                        <a:t>0.5318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>
                          <a:effectLst/>
                        </a:rPr>
                        <a:t>0.7046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>
                          <a:effectLst/>
                        </a:rPr>
                        <a:t>0.7156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</a:tr>
              <a:tr h="237626"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>
                          <a:effectLst/>
                        </a:rPr>
                        <a:t>0.3806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>
                          <a:effectLst/>
                        </a:rPr>
                        <a:t>0.3641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>
                          <a:effectLst/>
                        </a:rPr>
                        <a:t>0.9198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>
                          <a:effectLst/>
                        </a:rPr>
                        <a:t>1.0269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</a:tr>
              <a:tr h="237626"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>
                          <a:effectLst/>
                        </a:rPr>
                        <a:t>1.1301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>
                          <a:effectLst/>
                        </a:rPr>
                        <a:t>0.9857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>
                          <a:effectLst/>
                        </a:rPr>
                        <a:t>1.2166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 dirty="0">
                          <a:effectLst/>
                        </a:rPr>
                        <a:t>1.1761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</a:tr>
              <a:tr h="237626"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>
                          <a:effectLst/>
                        </a:rPr>
                        <a:t>0.7705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>
                          <a:effectLst/>
                        </a:rPr>
                        <a:t>0.5087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>
                          <a:effectLst/>
                        </a:rPr>
                        <a:t>1.3375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>
                          <a:effectLst/>
                        </a:rPr>
                        <a:t>1.0992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</a:tr>
              <a:tr h="237626"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>
                          <a:effectLst/>
                        </a:rPr>
                        <a:t>0.7241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>
                          <a:effectLst/>
                        </a:rPr>
                        <a:t>0.4026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 dirty="0">
                          <a:effectLst/>
                        </a:rPr>
                        <a:t>1.3229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>
                          <a:effectLst/>
                        </a:rPr>
                        <a:t>0.9651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</a:tr>
              <a:tr h="237626"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>
                          <a:effectLst/>
                        </a:rPr>
                        <a:t>4.2774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>
                          <a:effectLst/>
                        </a:rPr>
                        <a:t>1.5125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>
                          <a:effectLst/>
                        </a:rPr>
                        <a:t>2.2834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>
                          <a:effectLst/>
                        </a:rPr>
                        <a:t>2.4168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</a:tr>
              <a:tr h="237626"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>
                          <a:effectLst/>
                        </a:rPr>
                        <a:t>2.5568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>
                          <a:effectLst/>
                        </a:rPr>
                        <a:t>1.1647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>
                          <a:effectLst/>
                        </a:rPr>
                        <a:t>1.2102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>
                          <a:effectLst/>
                        </a:rPr>
                        <a:t>1.0305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</a:tr>
              <a:tr h="237626"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>
                          <a:effectLst/>
                        </a:rPr>
                        <a:t>4.1689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>
                          <a:effectLst/>
                        </a:rPr>
                        <a:t>4.2538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</a:tr>
            </a:tbl>
          </a:graphicData>
        </a:graphic>
      </p:graphicFrame>
      <p:graphicFrame>
        <p:nvGraphicFramePr>
          <p:cNvPr id="5" name="Tabelle 4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595574202"/>
              </p:ext>
            </p:extLst>
          </p:nvPr>
        </p:nvGraphicFramePr>
        <p:xfrm>
          <a:off x="4788024" y="833979"/>
          <a:ext cx="4176464" cy="4514894"/>
        </p:xfrm>
        <a:graphic>
          <a:graphicData uri="http://schemas.openxmlformats.org/drawingml/2006/table">
            <a:tbl>
              <a:tblPr>
                <a:tableStyleId>{616DA210-FB5B-4158-B5E0-FEB733F419BA}</a:tableStyleId>
              </a:tblPr>
              <a:tblGrid>
                <a:gridCol w="1044116"/>
                <a:gridCol w="1044116"/>
                <a:gridCol w="1044116"/>
                <a:gridCol w="1044116"/>
              </a:tblGrid>
              <a:tr h="237626">
                <a:tc gridSpan="4"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 dirty="0" smtClean="0">
                          <a:effectLst/>
                          <a:latin typeface="+mn-lt"/>
                        </a:rPr>
                        <a:t>CD34+/KDR+ </a:t>
                      </a:r>
                      <a:r>
                        <a:rPr lang="en-GB" sz="1100" u="none" strike="noStrike" dirty="0">
                          <a:effectLst/>
                          <a:latin typeface="+mn-lt"/>
                        </a:rPr>
                        <a:t>cell count/</a:t>
                      </a:r>
                      <a:r>
                        <a:rPr lang="en-GB" sz="1100" u="none" strike="noStrike" dirty="0" err="1">
                          <a:effectLst/>
                          <a:latin typeface="+mn-lt"/>
                        </a:rPr>
                        <a:t>ul</a:t>
                      </a:r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algn="l" fontAlgn="b"/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 hMerge="1">
                  <a:txBody>
                    <a:bodyPr/>
                    <a:lstStyle/>
                    <a:p>
                      <a:pPr algn="l" fontAlgn="b"/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</a:tr>
              <a:tr h="237626"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 dirty="0">
                          <a:effectLst/>
                          <a:latin typeface="+mn-lt"/>
                        </a:rPr>
                        <a:t>Placebo</a:t>
                      </a:r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tc hMerge="1">
                  <a:txBody>
                    <a:bodyPr/>
                    <a:lstStyle/>
                    <a:p>
                      <a:pPr algn="l" fontAlgn="b"/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 dirty="0">
                          <a:effectLst/>
                          <a:latin typeface="+mn-lt"/>
                        </a:rPr>
                        <a:t>rHDL</a:t>
                      </a:r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tc hMerge="1">
                  <a:txBody>
                    <a:bodyPr/>
                    <a:lstStyle/>
                    <a:p>
                      <a:pPr algn="l" fontAlgn="b"/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</a:tr>
              <a:tr h="237626"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 dirty="0">
                          <a:effectLst/>
                          <a:latin typeface="+mn-lt"/>
                        </a:rPr>
                        <a:t>baseline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 dirty="0">
                          <a:effectLst/>
                          <a:latin typeface="+mn-lt"/>
                        </a:rPr>
                        <a:t>follow-up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 dirty="0">
                          <a:effectLst/>
                          <a:latin typeface="+mn-lt"/>
                        </a:rPr>
                        <a:t>baseline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 dirty="0">
                          <a:effectLst/>
                          <a:latin typeface="+mn-lt"/>
                        </a:rPr>
                        <a:t>follow-up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</a:tr>
              <a:tr h="237626"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0.074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0.1048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0.2163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0.2236</a:t>
                      </a:r>
                    </a:p>
                  </a:txBody>
                  <a:tcPr marL="9525" marR="9525" marT="9525" marB="0" anchor="b"/>
                </a:tc>
              </a:tr>
              <a:tr h="237626"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0.0873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0.1013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0.1402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0.0817</a:t>
                      </a:r>
                    </a:p>
                  </a:txBody>
                  <a:tcPr marL="9525" marR="9525" marT="9525" marB="0" anchor="b"/>
                </a:tc>
              </a:tr>
              <a:tr h="237626"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0.1835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0.1237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0.1657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0.2192</a:t>
                      </a:r>
                    </a:p>
                  </a:txBody>
                  <a:tcPr marL="9525" marR="9525" marT="9525" marB="0" anchor="b"/>
                </a:tc>
              </a:tr>
              <a:tr h="237626"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0.1607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0.0547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0.1783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0.1856</a:t>
                      </a:r>
                    </a:p>
                  </a:txBody>
                  <a:tcPr marL="9525" marR="9525" marT="9525" marB="0" anchor="b"/>
                </a:tc>
              </a:tr>
              <a:tr h="237626"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0.2027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0.2817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0.1369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0.1478</a:t>
                      </a:r>
                    </a:p>
                  </a:txBody>
                  <a:tcPr marL="9525" marR="9525" marT="9525" marB="0" anchor="b"/>
                </a:tc>
              </a:tr>
              <a:tr h="237626"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0.1243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0.1136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0.2014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0.1729</a:t>
                      </a:r>
                    </a:p>
                  </a:txBody>
                  <a:tcPr marL="9525" marR="9525" marT="9525" marB="0" anchor="b"/>
                </a:tc>
              </a:tr>
              <a:tr h="237626"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0.1939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0.1367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0.1933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0.11</a:t>
                      </a:r>
                    </a:p>
                  </a:txBody>
                  <a:tcPr marL="9525" marR="9525" marT="9525" marB="0" anchor="b"/>
                </a:tc>
              </a:tr>
              <a:tr h="237626"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0.2685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0.058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0.2472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0.0967</a:t>
                      </a:r>
                    </a:p>
                  </a:txBody>
                  <a:tcPr marL="9525" marR="9525" marT="9525" marB="0" anchor="b"/>
                </a:tc>
              </a:tr>
              <a:tr h="237626"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0.2157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0.0985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0.228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0.1865</a:t>
                      </a:r>
                    </a:p>
                  </a:txBody>
                  <a:tcPr marL="9525" marR="9525" marT="9525" marB="0" anchor="b"/>
                </a:tc>
              </a:tr>
              <a:tr h="237626"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0.0448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0.1639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0.1502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0.1201</a:t>
                      </a:r>
                    </a:p>
                  </a:txBody>
                  <a:tcPr marL="9525" marR="9525" marT="9525" marB="0" anchor="b"/>
                </a:tc>
              </a:tr>
              <a:tr h="237626"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0.0575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0.2135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0.3158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0.1008</a:t>
                      </a:r>
                    </a:p>
                  </a:txBody>
                  <a:tcPr marL="9525" marR="9525" marT="9525" marB="0" anchor="b"/>
                </a:tc>
              </a:tr>
              <a:tr h="237626"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0.0716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0.0152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0.142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0.1267</a:t>
                      </a:r>
                    </a:p>
                  </a:txBody>
                  <a:tcPr marL="9525" marR="9525" marT="9525" marB="0" anchor="b"/>
                </a:tc>
              </a:tr>
              <a:tr h="237626"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0.0858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0.0732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0.0568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0.113</a:t>
                      </a:r>
                    </a:p>
                  </a:txBody>
                  <a:tcPr marL="9525" marR="9525" marT="9525" marB="0" anchor="b"/>
                </a:tc>
              </a:tr>
              <a:tr h="237626"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0.3662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0.3425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 anchor="b"/>
                </a:tc>
              </a:tr>
              <a:tr h="237626"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1.5611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0.1258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 anchor="b"/>
                </a:tc>
              </a:tr>
              <a:tr h="237626"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0.3062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0.3396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 anchor="b"/>
                </a:tc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3510850466"/>
      </p:ext>
    </p:extLst>
  </p:cSld>
  <p:clrMapOvr>
    <a:masterClrMapping/>
  </p:clrMapOvr>
</p:sld>
</file>

<file path=ppt/theme/theme1.xml><?xml version="1.0" encoding="utf-8"?>
<a:theme xmlns:a="http://schemas.openxmlformats.org/drawingml/2006/main" name="Larissa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42</Words>
  <Application>Microsoft Office PowerPoint</Application>
  <PresentationFormat>Bildschirmpräsentation (4:3)</PresentationFormat>
  <Paragraphs>134</Paragraphs>
  <Slides>1</Slides>
  <Notes>0</Notes>
  <HiddenSlides>0</HiddenSlides>
  <MMClips>0</MMClips>
  <ScaleCrop>false</ScaleCrop>
  <HeadingPairs>
    <vt:vector size="4" baseType="variant"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2" baseType="lpstr">
      <vt:lpstr>Larissa</vt:lpstr>
      <vt:lpstr>PowerPoint-Prä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Catherine</dc:creator>
  <cp:lastModifiedBy>Catherine</cp:lastModifiedBy>
  <cp:revision>2</cp:revision>
  <dcterms:created xsi:type="dcterms:W3CDTF">2016-10-28T17:55:56Z</dcterms:created>
  <dcterms:modified xsi:type="dcterms:W3CDTF">2016-10-28T18:09:25Z</dcterms:modified>
</cp:coreProperties>
</file>